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48C51-B9FB-4AF3-82B6-78B3B04985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D9CC5-1A66-42EB-BA34-01A5C54FAF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AC2F5-D305-49E6-A46B-79600207C8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9CFBD-51AA-4EB5-8623-17E7316070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EF39E-825A-4235-A35D-1C546B91C4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326D0-7146-4406-94C3-C27DE57412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0C4B1-9D26-4708-BF0B-DBFC7DA3FA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E8B83-CF78-469D-8580-B67D1EAD2F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1AEAD9-834A-4830-AE3D-83959670F1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FCC94-1638-4116-A647-F9C2C04673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A16B81-8446-473F-A36B-3ED9C1B1EB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546E9-E3CD-4621-B295-7E058BDE38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ru-R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ru-R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91D788-CC60-4D19-A734-404AFB886499}" type="slidenum">
              <a:rPr b="0" lang="ru-RU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Рисунок 6" descr=""/>
          <p:cNvPicPr/>
          <p:nvPr/>
        </p:nvPicPr>
        <p:blipFill>
          <a:blip r:embed="rId1"/>
          <a:stretch/>
        </p:blipFill>
        <p:spPr>
          <a:xfrm>
            <a:off x="404640" y="1660680"/>
            <a:ext cx="5848560" cy="2219040"/>
          </a:xfrm>
          <a:prstGeom prst="rect">
            <a:avLst/>
          </a:prstGeom>
          <a:ln w="0">
            <a:noFill/>
          </a:ln>
        </p:spPr>
      </p:pic>
      <p:pic>
        <p:nvPicPr>
          <p:cNvPr id="42" name="Рисунок 7" descr=""/>
          <p:cNvPicPr/>
          <p:nvPr/>
        </p:nvPicPr>
        <p:blipFill>
          <a:blip r:embed="rId2"/>
          <a:stretch/>
        </p:blipFill>
        <p:spPr>
          <a:xfrm>
            <a:off x="333360" y="5210280"/>
            <a:ext cx="5553000" cy="307656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3"/>
          <p:cNvSpPr/>
          <p:nvPr/>
        </p:nvSpPr>
        <p:spPr>
          <a:xfrm>
            <a:off x="836640" y="246240"/>
            <a:ext cx="583236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dat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Korneev et al "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uctural relationship of the lipid A acyl groups to activation of murine Toll-like receptor 4 by lipopolysaccharides from pathogenic strain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urkholderia mallei, Acinetobacte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umanni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seudomona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eruginos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4"/>
          <p:cNvSpPr/>
          <p:nvPr/>
        </p:nvSpPr>
        <p:spPr>
          <a:xfrm>
            <a:off x="836640" y="3981240"/>
            <a:ext cx="5545080" cy="824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Induction of  proinflammatory cytokines by various concentrations of LPS isolated from various bacteria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LISA quantification of IL-6 (A) and TNF (B) level in the supernatants of BMDM of WT mice after LPS stimulation at the indicated doses. All data are representative of three or more independent experiment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5"/>
          <p:cNvSpPr/>
          <p:nvPr/>
        </p:nvSpPr>
        <p:spPr>
          <a:xfrm>
            <a:off x="819000" y="8381880"/>
            <a:ext cx="5418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Induction of proinflammatory cytokines by LPS isolated from various bacteria in TLR4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acrophage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LISA quantification of IL-6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TNF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level in the supernatants of LPS-stimulated BMDM of TLR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 mice. All data are representative of three or more independent experiments. Data represent mean values ± SEM. *P &lt; 0.05, as calculated by Student’s t tes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15T13:24:06Z</dcterms:created>
  <dc:creator>user</dc:creator>
  <dc:description/>
  <dc:language>en-US</dc:language>
  <cp:lastModifiedBy>John</cp:lastModifiedBy>
  <dcterms:modified xsi:type="dcterms:W3CDTF">2015-10-16T12:52:20Z</dcterms:modified>
  <cp:revision>38</cp:revision>
  <dc:subject/>
  <dc:title>Слайд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